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236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249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623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5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708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268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249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594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031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475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103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994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769C6D-E217-48AA-857E-9900B5E3C1BB}" type="datetimeFigureOut">
              <a:rPr lang="en-US" smtClean="0"/>
              <a:t>1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CC3CE-08D0-4D53-8530-591403D072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202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571500" y="8347679"/>
            <a:ext cx="570229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457200" algn="l"/>
              </a:tabLs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3 Fig.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Chlorophyll, amino acid, soluble sugar, phenolic and flavonoid contents of cumin under salt stress.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Chlorophyll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content (S3a), a</a:t>
            </a:r>
            <a:r>
              <a:rPr lang="en-GB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mino acid (S3b), t</a:t>
            </a:r>
            <a:r>
              <a:rPr lang="en-GB" sz="1200" dirty="0" smtClean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otal soluble sugar (S3c), </a:t>
            </a:r>
            <a:r>
              <a:rPr lang="en-GB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phenolic and flavonoid contents (S3d) of cumin seedling grown under salinity stress.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Means ± SE followed by similar letters are significantly different at </a:t>
            </a:r>
            <a:r>
              <a:rPr lang="en-US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P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&lt;0.05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grpSp>
        <p:nvGrpSpPr>
          <p:cNvPr id="53" name="Group 52"/>
          <p:cNvGrpSpPr/>
          <p:nvPr/>
        </p:nvGrpSpPr>
        <p:grpSpPr>
          <a:xfrm>
            <a:off x="643434" y="48648"/>
            <a:ext cx="5574189" cy="8543244"/>
            <a:chOff x="619050" y="97416"/>
            <a:chExt cx="5574189" cy="8543244"/>
          </a:xfrm>
        </p:grpSpPr>
        <p:grpSp>
          <p:nvGrpSpPr>
            <p:cNvPr id="51" name="Group 50"/>
            <p:cNvGrpSpPr/>
            <p:nvPr/>
          </p:nvGrpSpPr>
          <p:grpSpPr>
            <a:xfrm>
              <a:off x="664760" y="97416"/>
              <a:ext cx="5528479" cy="8313397"/>
              <a:chOff x="664760" y="97416"/>
              <a:chExt cx="5528479" cy="8313397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64760" y="2422398"/>
                <a:ext cx="5528479" cy="2194560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64760" y="4605909"/>
                <a:ext cx="5528479" cy="2103120"/>
              </a:xfrm>
              <a:prstGeom prst="rect">
                <a:avLst/>
              </a:prstGeom>
            </p:spPr>
          </p:pic>
          <p:grpSp>
            <p:nvGrpSpPr>
              <p:cNvPr id="34" name="Group 33"/>
              <p:cNvGrpSpPr/>
              <p:nvPr/>
            </p:nvGrpSpPr>
            <p:grpSpPr>
              <a:xfrm>
                <a:off x="664760" y="97416"/>
                <a:ext cx="5528479" cy="2194560"/>
                <a:chOff x="664760" y="97416"/>
                <a:chExt cx="5528479" cy="2194560"/>
              </a:xfrm>
            </p:grpSpPr>
            <p:pic>
              <p:nvPicPr>
                <p:cNvPr id="12" name="Picture 11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664760" y="97416"/>
                  <a:ext cx="5528479" cy="2194560"/>
                </a:xfrm>
                <a:prstGeom prst="rect">
                  <a:avLst/>
                </a:prstGeom>
              </p:spPr>
            </p:pic>
            <p:sp>
              <p:nvSpPr>
                <p:cNvPr id="22" name="TextBox 21"/>
                <p:cNvSpPr txBox="1"/>
                <p:nvPr/>
              </p:nvSpPr>
              <p:spPr>
                <a:xfrm>
                  <a:off x="1352550" y="771525"/>
                  <a:ext cx="23596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2133600" y="809625"/>
                  <a:ext cx="29367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b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1752600" y="752475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2562225" y="1162050"/>
                  <a:ext cx="23596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3343275" y="1333500"/>
                  <a:ext cx="32252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 d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2971800" y="1171575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3799149" y="177997"/>
                  <a:ext cx="23596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4589724" y="378022"/>
                  <a:ext cx="27443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f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208724" y="158947"/>
                  <a:ext cx="22313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4999299" y="1282897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5789874" y="1349572"/>
                  <a:ext cx="30008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h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5427924" y="1311472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8" name="Group 37"/>
              <p:cNvGrpSpPr/>
              <p:nvPr/>
            </p:nvGrpSpPr>
            <p:grpSpPr>
              <a:xfrm>
                <a:off x="664760" y="6726023"/>
                <a:ext cx="2651464" cy="1684790"/>
                <a:chOff x="664760" y="6726023"/>
                <a:chExt cx="2651464" cy="1684790"/>
              </a:xfrm>
            </p:grpSpPr>
            <p:pic>
              <p:nvPicPr>
                <p:cNvPr id="17" name="Picture 16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664760" y="6750797"/>
                  <a:ext cx="2651464" cy="1660016"/>
                </a:xfrm>
                <a:prstGeom prst="rect">
                  <a:avLst/>
                </a:prstGeom>
              </p:spPr>
            </p:pic>
            <p:sp>
              <p:nvSpPr>
                <p:cNvPr id="35" name="TextBox 34"/>
                <p:cNvSpPr txBox="1"/>
                <p:nvPr/>
              </p:nvSpPr>
              <p:spPr>
                <a:xfrm>
                  <a:off x="1262576" y="6726023"/>
                  <a:ext cx="23596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2018226" y="6960973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2773876" y="6846673"/>
                  <a:ext cx="23596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49" name="Picture 48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417847" y="6750797"/>
                <a:ext cx="2761796" cy="1660016"/>
              </a:xfrm>
              <a:prstGeom prst="rect">
                <a:avLst/>
              </a:prstGeom>
            </p:spPr>
          </p:pic>
        </p:grpSp>
        <p:sp>
          <p:nvSpPr>
            <p:cNvPr id="52" name="TextBox 51"/>
            <p:cNvSpPr txBox="1"/>
            <p:nvPr/>
          </p:nvSpPr>
          <p:spPr>
            <a:xfrm>
              <a:off x="619050" y="2038853"/>
              <a:ext cx="3062057" cy="66018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4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                                                                      d</a:t>
              </a: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54472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84</Words>
  <Application>Microsoft Office PowerPoint</Application>
  <PresentationFormat>On-screen Show (4:3)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ang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inash Mishra</dc:creator>
  <cp:lastModifiedBy>Avinash Mishra</cp:lastModifiedBy>
  <cp:revision>11</cp:revision>
  <dcterms:created xsi:type="dcterms:W3CDTF">2015-07-30T06:57:39Z</dcterms:created>
  <dcterms:modified xsi:type="dcterms:W3CDTF">2015-11-21T07:01:41Z</dcterms:modified>
</cp:coreProperties>
</file>